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58"/>
  </p:normalViewPr>
  <p:slideViewPr>
    <p:cSldViewPr snapToGrid="0">
      <p:cViewPr varScale="1">
        <p:scale>
          <a:sx n="120" d="100"/>
          <a:sy n="120" d="100"/>
        </p:scale>
        <p:origin x="80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0AC20B-9265-5008-F5A3-C6E6C1CFEAB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C5957C6-0E38-560B-EC35-78EABBAC41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64F2D3-F782-35DC-E3EC-27A8854716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8C4E81-3B8C-E548-8445-AC0CE94B45AD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4EC557-61E0-49BF-D8BF-43A052470F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E6C4E4-A4DC-F087-E03E-31411A86CC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2B312-618D-144A-8841-1EBC091AC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81697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8D5E05-C524-53AA-4A60-B4197DEACE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7D139B9-F04E-ECA8-8DD4-AE96981249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AD7C40-6FCF-973A-EBBD-44597756B8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8C4E81-3B8C-E548-8445-AC0CE94B45AD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4BC8F8-EE56-6D43-A3D8-3F891518A3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4A6E55-88CC-9E1F-AC4E-13D5B0BEE9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2B312-618D-144A-8841-1EBC091AC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61508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F976FCE-D58A-63C5-1F20-97C8C1A3DD4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F527177-D48D-4B5C-2DBA-3FDFB131A42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39E42E-DA31-9C73-0AA8-5BCDE231A2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8C4E81-3B8C-E548-8445-AC0CE94B45AD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A2B21D-DB51-7BF4-0045-E9E2D77EF2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186E35-2D44-237D-98D3-300BC5836B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2B312-618D-144A-8841-1EBC091AC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29867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185C3E-347E-7177-37BF-6337133176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3B01D4-CA99-843F-7E21-E1CD648F154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A3018F-FA0B-CFB7-9EE7-525D765E69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8C4E81-3B8C-E548-8445-AC0CE94B45AD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0143C2-1005-76D7-AD5D-21CBF522A5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4CF94C-E9DD-F9A4-355A-5FC6FA8994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2B312-618D-144A-8841-1EBC091AC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8332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31ACAF-AEE1-F4FE-C4FC-972AC0947A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CDAF32F-C886-F1ED-5880-28760CEF77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3B1274-A24D-C0FA-3C79-2E4F99D267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8C4E81-3B8C-E548-8445-AC0CE94B45AD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FB05E5-F57C-22A4-91CA-FAA66B84F3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816293-5A0E-AF80-4720-DBFBA05E7D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2B312-618D-144A-8841-1EBC091AC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720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514E8C-6D61-6E9F-EA09-C2228A9C3E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6EA791D-D2EE-0EB4-E266-16D12E9199C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8AA04E9-3002-0CB0-2326-27846BED7B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8831A1-6A22-1308-4C8B-8D4B9585F2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8C4E81-3B8C-E548-8445-AC0CE94B45AD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C4E72AD-2563-CF74-20B1-0776B6C224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73BB6C-FA57-0050-7248-1C72926943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2B312-618D-144A-8841-1EBC091AC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3737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DACC89-80FD-B659-2F17-6CF031FDAB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D75818F-0AA2-4B45-6D3C-659837C1F1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530B984-FC6F-D4EE-9BF9-C692355894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E3491F4-B0CF-50D0-D269-0E78CC84F09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7166E3E-1504-953E-FE04-966B55EC2C1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EDC6F70-3D87-D7F5-D696-FB186FE1EB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8C4E81-3B8C-E548-8445-AC0CE94B45AD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4587F25-5C23-2859-70D2-A27F23BEF5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A85ED61-3CA4-4C7A-F0F1-B6B45F32AE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2B312-618D-144A-8841-1EBC091AC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10238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1FD150-F3DB-09CB-DB7B-77A311E5B0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140F695-14D9-297A-99D2-EF73075742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8C4E81-3B8C-E548-8445-AC0CE94B45AD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753679B-E29D-96E7-A36F-6F2C30C66E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712E643-9098-E520-8C59-D09227CD67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2B312-618D-144A-8841-1EBC091AC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81250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BF3C0A9-BDD3-D462-4A49-C5160C6A56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8C4E81-3B8C-E548-8445-AC0CE94B45AD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71E4050-66EC-70BE-9AFD-95ACC84BC2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0B19CD7-E788-BC2F-9A4A-25C56E991C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2B312-618D-144A-8841-1EBC091AC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14384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948F77-2B5D-064A-8730-DDEA729A99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ADD294-196A-816C-0368-5782DD10374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C2C9535-CFC0-289C-E76C-116B340050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83B7005-BABD-6A60-636A-5F983C935A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8C4E81-3B8C-E548-8445-AC0CE94B45AD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8E6116-947B-1F06-4ABE-349C5B8F33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C209795-4C4F-805D-62D7-B0F59B00ED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2B312-618D-144A-8841-1EBC091AC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61502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5FB1FD-CFDB-A886-B431-82E670A41B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5F38F66-7D23-5A87-7C85-323CF91FE29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4983FFD-1873-CE49-805A-09A8E1781B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C4EC053-3700-84FE-156F-41A0534059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8C4E81-3B8C-E548-8445-AC0CE94B45AD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6E71F7-C08B-3508-0507-D28C1DBC76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18B7FA-F042-C129-1EFF-EFDEBBD55E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2B312-618D-144A-8841-1EBC091AC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54003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AF5B9F6-866E-B8A8-AAD6-80C6412BCC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0A61B43-231F-5405-7908-462CB26E9D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78055B-C2FC-ACFB-2E96-1E483264F50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08C4E81-3B8C-E548-8445-AC0CE94B45AD}" type="datetimeFigureOut">
              <a:rPr lang="en-US" smtClean="0"/>
              <a:t>10/2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7895BD-E22C-1591-649B-EADE422D67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4E6AEA-0A28-0C72-A464-58E5EB03330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BF2B312-618D-144A-8841-1EBC091AC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10259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A59BE90-B550-F964-0BAE-B65BD847252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>
            <a:extLst>
              <a:ext uri="{FF2B5EF4-FFF2-40B4-BE49-F238E27FC236}">
                <a16:creationId xmlns:a16="http://schemas.microsoft.com/office/drawing/2014/main" id="{A431BC7B-E6DB-E250-76DB-D6225AC3307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65433" y="618681"/>
            <a:ext cx="5778842" cy="216706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E793D707-864B-9065-603B-0F6632EBCC1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5931" y="3470928"/>
            <a:ext cx="5900641" cy="221274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C3094C4-201D-737E-1E61-6BC5C5E01CE7}"/>
              </a:ext>
            </a:extLst>
          </p:cNvPr>
          <p:cNvSpPr txBox="1"/>
          <p:nvPr/>
        </p:nvSpPr>
        <p:spPr>
          <a:xfrm>
            <a:off x="154723" y="3146114"/>
            <a:ext cx="1605942" cy="276999"/>
          </a:xfrm>
          <a:prstGeom prst="rect">
            <a:avLst/>
          </a:prstGeom>
          <a:solidFill>
            <a:schemeClr val="bg2"/>
          </a:solidFill>
        </p:spPr>
        <p:txBody>
          <a:bodyPr wrap="square" rtlCol="0">
            <a:spAutoFit/>
          </a:bodyPr>
          <a:lstStyle/>
          <a:p>
            <a:r>
              <a:rPr lang="en-US" sz="1200" b="1" dirty="0"/>
              <a:t>B. Pre CRT ATG5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A375E15-2003-1CC4-ECAD-04528F7B11A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4723" y="595844"/>
            <a:ext cx="5900641" cy="221274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4728175-B0AD-C93D-072A-30C6DBE09F35}"/>
              </a:ext>
            </a:extLst>
          </p:cNvPr>
          <p:cNvSpPr txBox="1"/>
          <p:nvPr/>
        </p:nvSpPr>
        <p:spPr>
          <a:xfrm>
            <a:off x="148715" y="252188"/>
            <a:ext cx="1605942" cy="286062"/>
          </a:xfrm>
          <a:prstGeom prst="rect">
            <a:avLst/>
          </a:prstGeom>
          <a:solidFill>
            <a:schemeClr val="bg2"/>
          </a:solidFill>
        </p:spPr>
        <p:txBody>
          <a:bodyPr wrap="square" rtlCol="0">
            <a:spAutoFit/>
          </a:bodyPr>
          <a:lstStyle/>
          <a:p>
            <a:r>
              <a:rPr lang="en-US" sz="1200" b="1" dirty="0" err="1"/>
              <a:t>A.Pre</a:t>
            </a:r>
            <a:r>
              <a:rPr lang="en-US" sz="1200" b="1" dirty="0"/>
              <a:t> CRT  PGAM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9F69CCD-BF0B-0AA4-86E4-CDB48AA72A21}"/>
              </a:ext>
            </a:extLst>
          </p:cNvPr>
          <p:cNvSpPr txBox="1"/>
          <p:nvPr/>
        </p:nvSpPr>
        <p:spPr>
          <a:xfrm>
            <a:off x="6265433" y="263549"/>
            <a:ext cx="1857276" cy="287563"/>
          </a:xfrm>
          <a:prstGeom prst="rect">
            <a:avLst/>
          </a:prstGeom>
          <a:solidFill>
            <a:schemeClr val="bg2"/>
          </a:solidFill>
        </p:spPr>
        <p:txBody>
          <a:bodyPr wrap="square" rtlCol="0">
            <a:spAutoFit/>
          </a:bodyPr>
          <a:lstStyle/>
          <a:p>
            <a:r>
              <a:rPr lang="en-US" sz="1200" b="1" dirty="0"/>
              <a:t>C. Pre CRT MGMT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E7A5165-5F22-2157-6D71-CF4FA6320EA2}"/>
              </a:ext>
            </a:extLst>
          </p:cNvPr>
          <p:cNvSpPr txBox="1"/>
          <p:nvPr/>
        </p:nvSpPr>
        <p:spPr>
          <a:xfrm>
            <a:off x="6265433" y="3142354"/>
            <a:ext cx="2594362" cy="276999"/>
          </a:xfrm>
          <a:prstGeom prst="rect">
            <a:avLst/>
          </a:prstGeom>
          <a:solidFill>
            <a:schemeClr val="bg2"/>
          </a:solidFill>
        </p:spPr>
        <p:txBody>
          <a:bodyPr wrap="square" rtlCol="0">
            <a:spAutoFit/>
          </a:bodyPr>
          <a:lstStyle/>
          <a:p>
            <a:r>
              <a:rPr lang="en-US" sz="1200" b="1" dirty="0"/>
              <a:t>D. Pre CRT AKT1 </a:t>
            </a:r>
            <a:r>
              <a:rPr lang="en-US" sz="1200" b="1" dirty="0" err="1"/>
              <a:t>SeqID</a:t>
            </a:r>
            <a:r>
              <a:rPr lang="en-US" sz="1200" b="1" dirty="0"/>
              <a:t>=15627-83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93716BEA-D334-4EA4-9604-319ECE3F5DE6}"/>
              </a:ext>
            </a:extLst>
          </p:cNvPr>
          <p:cNvSpPr/>
          <p:nvPr/>
        </p:nvSpPr>
        <p:spPr>
          <a:xfrm>
            <a:off x="92938" y="195979"/>
            <a:ext cx="6003062" cy="268877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03FA5712-8554-18CA-23B4-99ADBBFE963C}"/>
              </a:ext>
            </a:extLst>
          </p:cNvPr>
          <p:cNvSpPr/>
          <p:nvPr/>
        </p:nvSpPr>
        <p:spPr>
          <a:xfrm>
            <a:off x="100898" y="3083348"/>
            <a:ext cx="5995102" cy="268877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507E3873-D6EA-85FA-CE17-86BC2F906E13}"/>
              </a:ext>
            </a:extLst>
          </p:cNvPr>
          <p:cNvSpPr/>
          <p:nvPr/>
        </p:nvSpPr>
        <p:spPr>
          <a:xfrm>
            <a:off x="6202816" y="195979"/>
            <a:ext cx="5916563" cy="268877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67CBB997-BA59-C896-E0D4-45450D63DE7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40719" y="3526122"/>
            <a:ext cx="5778842" cy="2167066"/>
          </a:xfrm>
          <a:prstGeom prst="rect">
            <a:avLst/>
          </a:prstGeom>
        </p:spPr>
      </p:pic>
      <p:sp>
        <p:nvSpPr>
          <p:cNvPr id="18" name="Rectangle 17">
            <a:extLst>
              <a:ext uri="{FF2B5EF4-FFF2-40B4-BE49-F238E27FC236}">
                <a16:creationId xmlns:a16="http://schemas.microsoft.com/office/drawing/2014/main" id="{2140AEEE-61D6-C449-464C-0D19567C4B29}"/>
              </a:ext>
            </a:extLst>
          </p:cNvPr>
          <p:cNvSpPr/>
          <p:nvPr/>
        </p:nvSpPr>
        <p:spPr>
          <a:xfrm>
            <a:off x="6195618" y="3083348"/>
            <a:ext cx="5916563" cy="268877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D48EA73-3A95-B5A7-753E-0C59DA9BD074}"/>
              </a:ext>
            </a:extLst>
          </p:cNvPr>
          <p:cNvSpPr txBox="1"/>
          <p:nvPr/>
        </p:nvSpPr>
        <p:spPr>
          <a:xfrm>
            <a:off x="31899" y="5891726"/>
            <a:ext cx="12192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buNone/>
            </a:pPr>
            <a:r>
              <a:rPr lang="en-US" sz="1200" b="1" dirty="0">
                <a:solidFill>
                  <a:srgbClr val="0A0A0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ure 3.</a:t>
            </a:r>
            <a:r>
              <a:rPr lang="en-US" sz="1200" dirty="0">
                <a:solidFill>
                  <a:srgbClr val="0A0A0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Progression free survival analysis for selected signals employing pre CRT (baseline) serum levels.  PGAM2 (</a:t>
            </a:r>
            <a:r>
              <a:rPr lang="en-US" sz="1200" b="1" dirty="0">
                <a:solidFill>
                  <a:srgbClr val="0A0A0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</a:t>
            </a:r>
            <a:r>
              <a:rPr lang="en-US" sz="1200" dirty="0">
                <a:solidFill>
                  <a:srgbClr val="0A0A0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, ATG5 (</a:t>
            </a:r>
            <a:r>
              <a:rPr lang="en-US" sz="1200" b="1" dirty="0">
                <a:solidFill>
                  <a:srgbClr val="0A0A0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B</a:t>
            </a:r>
            <a:r>
              <a:rPr lang="en-US" sz="1200" dirty="0">
                <a:solidFill>
                  <a:srgbClr val="0A0A0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, MGMT (</a:t>
            </a:r>
            <a:r>
              <a:rPr lang="en-US" sz="1200" b="1" dirty="0">
                <a:solidFill>
                  <a:srgbClr val="0A0A0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</a:t>
            </a:r>
            <a:r>
              <a:rPr lang="en-US" sz="1200" dirty="0">
                <a:solidFill>
                  <a:srgbClr val="0A0A0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, AKT1(</a:t>
            </a:r>
            <a:r>
              <a:rPr lang="en-US" sz="1200" b="1" dirty="0">
                <a:solidFill>
                  <a:srgbClr val="0A0A0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D</a:t>
            </a:r>
            <a:r>
              <a:rPr lang="en-US" sz="1200" dirty="0">
                <a:solidFill>
                  <a:srgbClr val="0A0A0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) are visualized at the 25</a:t>
            </a:r>
            <a:r>
              <a:rPr lang="en-US" sz="1200" baseline="30000" dirty="0">
                <a:solidFill>
                  <a:srgbClr val="0A0A0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h</a:t>
            </a:r>
            <a:r>
              <a:rPr lang="en-US" sz="1200" dirty="0">
                <a:solidFill>
                  <a:srgbClr val="0A0A0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, 50</a:t>
            </a:r>
            <a:r>
              <a:rPr lang="en-US" sz="1200" baseline="30000" dirty="0">
                <a:solidFill>
                  <a:srgbClr val="0A0A0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h</a:t>
            </a:r>
            <a:r>
              <a:rPr lang="en-US" sz="1200" dirty="0">
                <a:solidFill>
                  <a:srgbClr val="0A0A0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and 75</a:t>
            </a:r>
            <a:r>
              <a:rPr lang="en-US" sz="1200" baseline="30000" dirty="0">
                <a:solidFill>
                  <a:srgbClr val="0A0A0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h</a:t>
            </a:r>
            <a:r>
              <a:rPr lang="en-US" sz="1200" dirty="0">
                <a:solidFill>
                  <a:srgbClr val="0A0A0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percentile. PGAM2 and ATG5 are significant in at least two (ATG5) or all (PGAM2) categories in contrast to MGMT and AKT1. PGAM2 features a prominent node in the protein-protein interaction network (Figure 4, lower right corner). ATG5 is featured in pathway representations of autophagy. 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337235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22</Words>
  <Application>Microsoft Macintosh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rauze, Andra (NIH/NCI) [E]</dc:creator>
  <cp:lastModifiedBy>Krauze, Andra (NIH/NCI) [E]</cp:lastModifiedBy>
  <cp:revision>1</cp:revision>
  <dcterms:created xsi:type="dcterms:W3CDTF">2025-10-28T19:13:48Z</dcterms:created>
  <dcterms:modified xsi:type="dcterms:W3CDTF">2025-10-28T19:16:42Z</dcterms:modified>
</cp:coreProperties>
</file>